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75" r:id="rId2"/>
    <p:sldId id="257" r:id="rId3"/>
    <p:sldId id="258" r:id="rId4"/>
    <p:sldId id="261" r:id="rId5"/>
    <p:sldId id="262" r:id="rId6"/>
    <p:sldId id="264" r:id="rId7"/>
    <p:sldId id="316" r:id="rId8"/>
    <p:sldId id="347" r:id="rId9"/>
    <p:sldId id="348" r:id="rId10"/>
    <p:sldId id="349" r:id="rId11"/>
    <p:sldId id="350" r:id="rId12"/>
    <p:sldId id="351" r:id="rId13"/>
    <p:sldId id="352" r:id="rId14"/>
    <p:sldId id="344" r:id="rId15"/>
    <p:sldId id="345" r:id="rId16"/>
    <p:sldId id="346" r:id="rId17"/>
    <p:sldId id="353" r:id="rId18"/>
    <p:sldId id="354" r:id="rId19"/>
    <p:sldId id="355" r:id="rId20"/>
    <p:sldId id="356" r:id="rId21"/>
    <p:sldId id="357" r:id="rId22"/>
    <p:sldId id="358" r:id="rId23"/>
    <p:sldId id="282" r:id="rId24"/>
    <p:sldId id="283" r:id="rId25"/>
    <p:sldId id="359" r:id="rId26"/>
    <p:sldId id="360" r:id="rId27"/>
    <p:sldId id="361" r:id="rId28"/>
    <p:sldId id="362" r:id="rId29"/>
    <p:sldId id="363" r:id="rId30"/>
    <p:sldId id="291" r:id="rId31"/>
    <p:sldId id="364" r:id="rId32"/>
    <p:sldId id="365" r:id="rId33"/>
    <p:sldId id="366" r:id="rId34"/>
    <p:sldId id="297" r:id="rId35"/>
    <p:sldId id="298" r:id="rId36"/>
    <p:sldId id="367" r:id="rId37"/>
    <p:sldId id="301" r:id="rId38"/>
    <p:sldId id="368" r:id="rId39"/>
    <p:sldId id="369" r:id="rId40"/>
    <p:sldId id="370" r:id="rId41"/>
    <p:sldId id="371" r:id="rId42"/>
    <p:sldId id="372" r:id="rId43"/>
    <p:sldId id="340" r:id="rId44"/>
    <p:sldId id="341" r:id="rId45"/>
    <p:sldId id="342" r:id="rId46"/>
    <p:sldId id="307" r:id="rId47"/>
    <p:sldId id="373" r:id="rId48"/>
    <p:sldId id="374" r:id="rId49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8" Type="http://schemas.openxmlformats.org/officeDocument/2006/relationships/slide" Target="slides/slide7.xml"/><Relationship Id="rId51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88C8A5-B971-6BF0-6C67-D8C91B2357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98CE98C-2761-B439-6A7C-35AAB70949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3DFA38E-8A09-5D93-3903-D08858A99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67A7E03-BB0C-5B8D-DF78-171C0437C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1794181-4275-0588-4A0B-893C27029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7463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F3BFC6A-6A9B-060F-D109-C4E24331E4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56DEF4AB-6E87-1B63-0767-A60A9EFF40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9DFF481A-FAD7-2CE9-50F7-1B913C990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9B4A887-D4FA-B2D3-8195-44017FBBC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D3935C7-9402-4BE1-A98C-7DA98B647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35730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1659F14-438A-961D-AD81-A1DFE2F293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2E9FD65D-95FA-F97F-3973-EDFED7872A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5E2D79B-E2A7-881C-B8AA-606D45668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E8DF576-8780-F6BF-F8F7-3F13306E4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8814C37-68A7-2F64-C471-E4421DA1F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42764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B3692BA-9DFE-BBFD-4BA0-004D23EA60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8DF8D5FF-9290-BDA4-5DD5-001D90EC68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49BAD8C-9379-0004-E1E6-378C69364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8AA262E1-4B97-CF29-EA71-1806E46E9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C3C9D7B-994A-B8E5-F69F-5FE459079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5285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14FCD0C-5B86-909B-6EFB-A3FD4B6619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4A3875CB-1DB6-C661-9A26-A93DDC3718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FBA98FB-6D3C-0C2E-F066-DFA9FC5F9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D4389F2-1B05-AD03-2BCD-975B24CD1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579BA01-B1A0-81A2-2AC2-3480F4A4D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32240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78E2B43-DFFE-EBFE-1478-F17291B5C2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66E5822A-863F-1A0E-3787-3A0C85BD65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0194FA2-37AC-2F58-8250-FDA022C4C6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7EA08D1-4B21-6F60-3C9C-B3402FAD6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8F9FBC8-BF43-8F79-19F7-5498F3FB9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B874424F-4975-F4CD-B16A-6048D42CB8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04033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D84F13A-E32E-62F1-733D-8C093E0FEA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847739E1-A233-28EB-332A-EF1AA71933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53544B3-9E90-4FD0-2C44-4970E11983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18A4D956-8360-C929-507F-0627B4E980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37F68D16-7863-81EA-9490-C669D944E9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D8525443-C432-0633-0A4B-697B65B5C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88E5ED4D-76C5-C2E4-F075-5BB802B6F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A9935663-C0C7-8914-2ED2-0F9ABD2110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07285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6050D80-54A1-674D-B32D-D702CAEBC9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BEBFB300-508E-4852-F400-2719C2A9C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A3EAC645-46DD-B854-7430-85D64991D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940DCCD5-BA7F-27E0-BCA3-3EC4BB310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95112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C380C595-23A4-FF51-7B65-28C12222E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D0776501-5DC7-F93F-F6D1-B7CF0F3657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5496A13E-34F1-A446-9778-C09D15DD8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4202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242F347-AF29-9907-FC28-E4F4A7DD9C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7766209A-8AB9-26C9-6449-75001F88D5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729D9965-7C04-BD37-AD9E-8696EBA77E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E7FE9A85-3639-133D-C596-B7B29EFA36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E51764E7-91F4-D8F6-A8DA-FD68888112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6CA33199-ECA1-B82C-C433-D38F4A91CA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59066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FD03085-C8EE-9323-6A85-EC72E39EDD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E09457AB-3069-77E4-55CE-57639CA211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821768A7-0B50-2B66-0821-37072960D0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9DD9C3D2-8209-C247-48E7-A58E6D4DC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F20E156-047E-661A-155B-763D79E00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57AE9CF-1D82-50F4-76B3-331B6031D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80126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E4604CF2-6525-830F-D411-04D721634B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9655563C-3EBC-D391-CD5D-82A6495A03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0E8F703-E04E-1EF1-885D-6D7501FA54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41DD5-3BBD-41B2-8C86-61F465F9B8A6}" type="datetimeFigureOut">
              <a:rPr lang="pt-BR" smtClean="0"/>
              <a:t>07/07/2023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D6781D9-4B99-495E-F55F-92F27CFC04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1036B8C-DEF2-E83F-C332-089FCA920A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41826-558E-4991-AE50-51763095FE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05022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8C6553D-BECA-D169-B9C2-77886B9F45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dirty="0" err="1"/>
              <a:t>Supplementary</a:t>
            </a:r>
            <a:r>
              <a:rPr lang="pt-BR"/>
              <a:t> material 1</a:t>
            </a:r>
            <a:endParaRPr lang="pt-BR" dirty="0"/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80E6A5D-200C-1FFD-EB2F-82D28A8694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pt-BR" dirty="0">
                <a:solidFill>
                  <a:srgbClr val="FF0000"/>
                </a:solidFill>
              </a:rPr>
              <a:t>Mass </a:t>
            </a:r>
            <a:r>
              <a:rPr lang="pt-BR" dirty="0" err="1">
                <a:solidFill>
                  <a:srgbClr val="FF0000"/>
                </a:solidFill>
              </a:rPr>
              <a:t>Spectra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of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the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compounds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identified</a:t>
            </a:r>
            <a:r>
              <a:rPr lang="pt-BR" dirty="0">
                <a:solidFill>
                  <a:srgbClr val="FF0000"/>
                </a:solidFill>
              </a:rPr>
              <a:t> in </a:t>
            </a:r>
            <a:r>
              <a:rPr lang="pt-BR" dirty="0" err="1">
                <a:solidFill>
                  <a:srgbClr val="FF0000"/>
                </a:solidFill>
              </a:rPr>
              <a:t>Table</a:t>
            </a:r>
            <a:r>
              <a:rPr lang="pt-BR" dirty="0">
                <a:solidFill>
                  <a:srgbClr val="FF0000"/>
                </a:solidFill>
              </a:rPr>
              <a:t> 1 – ESI Positive</a:t>
            </a:r>
          </a:p>
          <a:p>
            <a:pPr marL="0" indent="0">
              <a:buNone/>
            </a:pPr>
            <a:endParaRPr lang="pt-BR" dirty="0">
              <a:solidFill>
                <a:srgbClr val="FF0000"/>
              </a:solidFill>
            </a:endParaRPr>
          </a:p>
          <a:p>
            <a:pPr marL="0" indent="0">
              <a:buNone/>
            </a:pPr>
            <a:r>
              <a:rPr lang="pt-BR" dirty="0">
                <a:solidFill>
                  <a:srgbClr val="FF0000"/>
                </a:solidFill>
              </a:rPr>
              <a:t>The </a:t>
            </a:r>
            <a:r>
              <a:rPr lang="pt-BR" dirty="0" err="1">
                <a:solidFill>
                  <a:srgbClr val="FF0000"/>
                </a:solidFill>
              </a:rPr>
              <a:t>numbers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on</a:t>
            </a:r>
            <a:r>
              <a:rPr lang="pt-BR" dirty="0">
                <a:solidFill>
                  <a:srgbClr val="FF0000"/>
                </a:solidFill>
              </a:rPr>
              <a:t> top </a:t>
            </a:r>
            <a:r>
              <a:rPr lang="pt-BR" dirty="0" err="1">
                <a:solidFill>
                  <a:srgbClr val="FF0000"/>
                </a:solidFill>
              </a:rPr>
              <a:t>of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the</a:t>
            </a:r>
            <a:r>
              <a:rPr lang="pt-BR" dirty="0">
                <a:solidFill>
                  <a:srgbClr val="FF0000"/>
                </a:solidFill>
              </a:rPr>
              <a:t> slides </a:t>
            </a:r>
            <a:r>
              <a:rPr lang="pt-BR" dirty="0" err="1">
                <a:solidFill>
                  <a:srgbClr val="FF0000"/>
                </a:solidFill>
              </a:rPr>
              <a:t>correspond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to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the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metabolites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on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Table</a:t>
            </a:r>
            <a:r>
              <a:rPr lang="pt-BR" dirty="0">
                <a:solidFill>
                  <a:srgbClr val="FF0000"/>
                </a:solidFill>
              </a:rPr>
              <a:t> 1.</a:t>
            </a:r>
          </a:p>
          <a:p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1304746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47F1F0AC-2997-8409-8BA7-B1456D3C3C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A020CAAA-BC8C-2B55-6266-4481F9C2340A}"/>
              </a:ext>
            </a:extLst>
          </p:cNvPr>
          <p:cNvSpPr txBox="1"/>
          <p:nvPr/>
        </p:nvSpPr>
        <p:spPr>
          <a:xfrm>
            <a:off x="9660835" y="291548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85044449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AC50C1B2-2883-8159-3945-47E19C90D5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81037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7F5786FE-D4A2-BDD2-F671-FCCDA91172CD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3180346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37428E01-428F-6398-8E89-C2391CDC28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8B670913-84C9-C3E7-885D-12BAEABD2175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14703076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m 6">
            <a:extLst>
              <a:ext uri="{FF2B5EF4-FFF2-40B4-BE49-F238E27FC236}">
                <a16:creationId xmlns:a16="http://schemas.microsoft.com/office/drawing/2014/main" id="{60F71293-7CAC-E3A4-96CF-8782D504FE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8" name="CaixaDeTexto 7">
            <a:extLst>
              <a:ext uri="{FF2B5EF4-FFF2-40B4-BE49-F238E27FC236}">
                <a16:creationId xmlns:a16="http://schemas.microsoft.com/office/drawing/2014/main" id="{974FB8FB-EBDA-ABCC-CDDD-ED6762764715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144090829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64475C3B-C5B0-6EB7-175B-42DCB4181A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5EC672D2-1DF6-E890-12FC-4D0D56151005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203610251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8A0DB12-3CA1-0316-7910-DC1A34685E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792BD99A-66CD-6775-9EA5-8064EE83EE3D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144284134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4C94A3EA-FC5D-BF10-E2EF-852FFEAC54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3BC15E96-44E5-6E0C-3987-B13724FBA218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39318116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8ED2C5D-09BB-735C-E475-20B481A02C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15EF0249-38ED-53EE-F0C3-CB5B60417659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270462780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0FE427B1-FCB7-F9DF-2660-E25D9A93F2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CD37366D-F894-8170-94D3-752F1571A9C4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46911485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01456ABD-5A82-5D38-BABD-6282B913D5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A30746FF-9583-CCC4-2D2E-8928D0BFED2F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3919642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Espaço Reservado para Conteúdo 4">
            <a:extLst>
              <a:ext uri="{FF2B5EF4-FFF2-40B4-BE49-F238E27FC236}">
                <a16:creationId xmlns:a16="http://schemas.microsoft.com/office/drawing/2014/main" id="{2D067AD5-80CF-63CB-F8E5-6C51FF1AE95D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>
          <a:blip r:embed="rId2"/>
          <a:stretch>
            <a:fillRect/>
          </a:stretch>
        </p:blipFill>
        <p:spPr>
          <a:xfrm>
            <a:off x="0" y="442913"/>
            <a:ext cx="10515600" cy="5972175"/>
          </a:xfrm>
        </p:spPr>
      </p:pic>
      <p:sp>
        <p:nvSpPr>
          <p:cNvPr id="2" name="CaixaDeTexto 1">
            <a:extLst>
              <a:ext uri="{FF2B5EF4-FFF2-40B4-BE49-F238E27FC236}">
                <a16:creationId xmlns:a16="http://schemas.microsoft.com/office/drawing/2014/main" id="{C1108B55-7F13-9647-1B41-E93885C86A8A}"/>
              </a:ext>
            </a:extLst>
          </p:cNvPr>
          <p:cNvSpPr txBox="1"/>
          <p:nvPr/>
        </p:nvSpPr>
        <p:spPr>
          <a:xfrm>
            <a:off x="9660835" y="291548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131144620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2CEF060D-ACE6-DBD7-3222-AD7491279C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C863EB75-920B-52AC-C309-FC8BDDF09314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266917512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8A9D3497-35EA-F73F-0CB4-901B48E522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4530606B-4F96-1239-23D7-349BAC661996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415597167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EA7CE402-56E2-59D3-30EE-1D4E7206E8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7FC52B16-F06D-A697-C839-19D9B05AE1D1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400253910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47F48407-7DA5-0FEF-3DFB-76DD137D2E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3037979D-5922-1BC8-8306-067BCD6CE9CD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9</a:t>
            </a:r>
          </a:p>
        </p:txBody>
      </p:sp>
    </p:spTree>
    <p:extLst>
      <p:ext uri="{BB962C8B-B14F-4D97-AF65-F5344CB8AC3E}">
        <p14:creationId xmlns:p14="http://schemas.microsoft.com/office/powerpoint/2010/main" val="168595500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596A09AE-6AAE-40F6-50CC-753CB1B8AF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86C7AA5E-21B7-CE24-24AF-1CB8B78AA219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9</a:t>
            </a:r>
          </a:p>
        </p:txBody>
      </p:sp>
    </p:spTree>
    <p:extLst>
      <p:ext uri="{BB962C8B-B14F-4D97-AF65-F5344CB8AC3E}">
        <p14:creationId xmlns:p14="http://schemas.microsoft.com/office/powerpoint/2010/main" val="420570840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D877419-7659-B7BE-66CE-BDB1D7FD17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DC5365E0-037B-B8A8-4CD3-DCCE5AEF96E9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9</a:t>
            </a:r>
          </a:p>
        </p:txBody>
      </p:sp>
    </p:spTree>
    <p:extLst>
      <p:ext uri="{BB962C8B-B14F-4D97-AF65-F5344CB8AC3E}">
        <p14:creationId xmlns:p14="http://schemas.microsoft.com/office/powerpoint/2010/main" val="71147948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5CE04110-0F0A-AEFE-162F-3652F8152DA2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0</a:t>
            </a:r>
          </a:p>
        </p:txBody>
      </p:sp>
      <p:pic>
        <p:nvPicPr>
          <p:cNvPr id="6" name="Imagem 5">
            <a:extLst>
              <a:ext uri="{FF2B5EF4-FFF2-40B4-BE49-F238E27FC236}">
                <a16:creationId xmlns:a16="http://schemas.microsoft.com/office/drawing/2014/main" id="{73144BAE-1942-E5B6-1B08-FB35FA6B3F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</p:spTree>
    <p:extLst>
      <p:ext uri="{BB962C8B-B14F-4D97-AF65-F5344CB8AC3E}">
        <p14:creationId xmlns:p14="http://schemas.microsoft.com/office/powerpoint/2010/main" val="77883257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D35DCFA-8F43-369B-0ED4-1DFD742CD3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1A6BC68A-EBAD-CD5F-384B-4250F1393115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45747450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C4EA9983-59E6-6E6C-70DA-332717A59C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81037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F9879551-5A39-E3DF-9085-44575D600150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238609522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21B7FBA7-3F96-7678-B30D-0090FB18CC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4F20C855-9B42-C00C-49F8-0738978F53E9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32762120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4912932-C708-BF37-2382-804ACF501B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8225" y="557212"/>
            <a:ext cx="10115550" cy="5743575"/>
          </a:xfrm>
          <a:prstGeom prst="rect">
            <a:avLst/>
          </a:prstGeom>
        </p:spPr>
      </p:pic>
      <p:sp>
        <p:nvSpPr>
          <p:cNvPr id="2" name="CaixaDeTexto 1">
            <a:extLst>
              <a:ext uri="{FF2B5EF4-FFF2-40B4-BE49-F238E27FC236}">
                <a16:creationId xmlns:a16="http://schemas.microsoft.com/office/drawing/2014/main" id="{59823605-B6C3-88CC-0B26-2D172DBA52DE}"/>
              </a:ext>
            </a:extLst>
          </p:cNvPr>
          <p:cNvSpPr txBox="1"/>
          <p:nvPr/>
        </p:nvSpPr>
        <p:spPr>
          <a:xfrm>
            <a:off x="9660835" y="291548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29164607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6AADAE7-3DB8-6923-7FD6-60A9031AFDA4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0" y="365125"/>
            <a:ext cx="10515600" cy="1325563"/>
          </a:xfrm>
        </p:spPr>
        <p:txBody>
          <a:bodyPr/>
          <a:lstStyle/>
          <a:p>
            <a:r>
              <a:rPr lang="pt-BR" dirty="0"/>
              <a:t>   3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</a:t>
            </a:r>
          </a:p>
        </p:txBody>
      </p:sp>
      <p:pic>
        <p:nvPicPr>
          <p:cNvPr id="5" name="Imagem 4">
            <a:extLst>
              <a:ext uri="{FF2B5EF4-FFF2-40B4-BE49-F238E27FC236}">
                <a16:creationId xmlns:a16="http://schemas.microsoft.com/office/drawing/2014/main" id="{B82EB93F-9593-A6A8-5A62-2A7F28FB24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E797CFBC-0BE6-3856-2BFF-0A63BDB3784E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3392120054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1751A3D-7A81-AE3E-6A32-4351F26160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1818AD90-9AED-9E4E-4ADC-8F9B264EB5BA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3613810262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A44690B2-6AB0-63B4-D42E-EFA9EE473F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67C4CC51-2BB3-2ACC-D7CC-C657A024B39A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316904073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9225BBB9-1FFA-0D89-1A81-630C25D405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1E01BC9D-9962-D1F0-6863-A9A5DD3B9967}"/>
              </a:ext>
            </a:extLst>
          </p:cNvPr>
          <p:cNvSpPr txBox="1"/>
          <p:nvPr/>
        </p:nvSpPr>
        <p:spPr>
          <a:xfrm>
            <a:off x="9538981" y="303813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418366446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905B09E2-A55E-FAF6-77BF-3E951DE67365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2</a:t>
            </a:r>
          </a:p>
        </p:txBody>
      </p:sp>
      <p:pic>
        <p:nvPicPr>
          <p:cNvPr id="7" name="Imagem 6">
            <a:extLst>
              <a:ext uri="{FF2B5EF4-FFF2-40B4-BE49-F238E27FC236}">
                <a16:creationId xmlns:a16="http://schemas.microsoft.com/office/drawing/2014/main" id="{4EB5DC38-07F2-955A-51C6-C70BC4F077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</p:spTree>
    <p:extLst>
      <p:ext uri="{BB962C8B-B14F-4D97-AF65-F5344CB8AC3E}">
        <p14:creationId xmlns:p14="http://schemas.microsoft.com/office/powerpoint/2010/main" val="1425989828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m 5">
            <a:extLst>
              <a:ext uri="{FF2B5EF4-FFF2-40B4-BE49-F238E27FC236}">
                <a16:creationId xmlns:a16="http://schemas.microsoft.com/office/drawing/2014/main" id="{2F83D010-1233-EA8C-B9C0-E37CD86A70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</p:spPr>
      </p:pic>
      <p:sp>
        <p:nvSpPr>
          <p:cNvPr id="7" name="CaixaDeTexto 6">
            <a:extLst>
              <a:ext uri="{FF2B5EF4-FFF2-40B4-BE49-F238E27FC236}">
                <a16:creationId xmlns:a16="http://schemas.microsoft.com/office/drawing/2014/main" id="{C712AEFB-D195-0DF1-B603-7F13FBC219A8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2</a:t>
            </a:r>
          </a:p>
        </p:txBody>
      </p:sp>
    </p:spTree>
    <p:extLst>
      <p:ext uri="{BB962C8B-B14F-4D97-AF65-F5344CB8AC3E}">
        <p14:creationId xmlns:p14="http://schemas.microsoft.com/office/powerpoint/2010/main" val="153318742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DA57477C-2675-F263-5C7F-506B86F87F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8" name="CaixaDeTexto 7">
            <a:extLst>
              <a:ext uri="{FF2B5EF4-FFF2-40B4-BE49-F238E27FC236}">
                <a16:creationId xmlns:a16="http://schemas.microsoft.com/office/drawing/2014/main" id="{8B832727-25BE-1A48-8169-CFCF01F43DFF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2</a:t>
            </a:r>
          </a:p>
        </p:txBody>
      </p:sp>
    </p:spTree>
    <p:extLst>
      <p:ext uri="{BB962C8B-B14F-4D97-AF65-F5344CB8AC3E}">
        <p14:creationId xmlns:p14="http://schemas.microsoft.com/office/powerpoint/2010/main" val="2038272118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338DA0B3-D9D5-8B60-2C2A-5CE2BCF613F8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3</a:t>
            </a:r>
          </a:p>
        </p:txBody>
      </p:sp>
      <p:pic>
        <p:nvPicPr>
          <p:cNvPr id="7" name="Imagem 6">
            <a:extLst>
              <a:ext uri="{FF2B5EF4-FFF2-40B4-BE49-F238E27FC236}">
                <a16:creationId xmlns:a16="http://schemas.microsoft.com/office/drawing/2014/main" id="{525047CC-C9AB-9DEA-6DCA-3F00B85B46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</p:spTree>
    <p:extLst>
      <p:ext uri="{BB962C8B-B14F-4D97-AF65-F5344CB8AC3E}">
        <p14:creationId xmlns:p14="http://schemas.microsoft.com/office/powerpoint/2010/main" val="3301094228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EF7175C-2318-30EE-AC0F-2D2A37A78B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FB9627F0-5939-093F-880C-C5DD5398218F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3</a:t>
            </a:r>
          </a:p>
        </p:txBody>
      </p:sp>
    </p:spTree>
    <p:extLst>
      <p:ext uri="{BB962C8B-B14F-4D97-AF65-F5344CB8AC3E}">
        <p14:creationId xmlns:p14="http://schemas.microsoft.com/office/powerpoint/2010/main" val="2888226857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D2611527-A484-A862-EEF2-217CBB6955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81037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E1E46D74-540E-7695-5271-8B40B906E575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3</a:t>
            </a:r>
          </a:p>
        </p:txBody>
      </p:sp>
    </p:spTree>
    <p:extLst>
      <p:ext uri="{BB962C8B-B14F-4D97-AF65-F5344CB8AC3E}">
        <p14:creationId xmlns:p14="http://schemas.microsoft.com/office/powerpoint/2010/main" val="18769438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5D017E9B-D74B-EEC8-E18E-CA9A001D8A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589" y="291548"/>
            <a:ext cx="11298821" cy="6415432"/>
          </a:xfrm>
          <a:prstGeom prst="rect">
            <a:avLst/>
          </a:prstGeom>
        </p:spPr>
      </p:pic>
      <p:sp>
        <p:nvSpPr>
          <p:cNvPr id="2" name="CaixaDeTexto 1">
            <a:extLst>
              <a:ext uri="{FF2B5EF4-FFF2-40B4-BE49-F238E27FC236}">
                <a16:creationId xmlns:a16="http://schemas.microsoft.com/office/drawing/2014/main" id="{19294B58-E822-06BA-776F-5C610FFC7308}"/>
              </a:ext>
            </a:extLst>
          </p:cNvPr>
          <p:cNvSpPr txBox="1"/>
          <p:nvPr/>
        </p:nvSpPr>
        <p:spPr>
          <a:xfrm>
            <a:off x="9660835" y="291548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234138652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D19F418A-D56C-FDD9-C810-15017780ECAA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4</a:t>
            </a:r>
          </a:p>
        </p:txBody>
      </p:sp>
      <p:pic>
        <p:nvPicPr>
          <p:cNvPr id="6" name="Imagem 5">
            <a:extLst>
              <a:ext uri="{FF2B5EF4-FFF2-40B4-BE49-F238E27FC236}">
                <a16:creationId xmlns:a16="http://schemas.microsoft.com/office/drawing/2014/main" id="{4D785221-3445-50C1-6E8D-EB451AAA07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</p:spTree>
    <p:extLst>
      <p:ext uri="{BB962C8B-B14F-4D97-AF65-F5344CB8AC3E}">
        <p14:creationId xmlns:p14="http://schemas.microsoft.com/office/powerpoint/2010/main" val="307633428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75A86FC1-3E17-D52B-802D-3B55E3A926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47F17E7E-D835-CC2A-BAC4-4944436E7038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1797197166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4F793647-CEF0-2A6C-1667-1D9E6C9B73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44AE0AF2-8C1D-B79E-4719-25A6BFE5B83A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736985797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EE25C6C8-A21B-8367-7863-28323048BB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013019EB-B9FC-08F2-E9FC-F86B7C9BADA6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255085351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2291A3B-A934-E059-8568-60A2244AC1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F2FF8EC0-4B00-42F5-D907-275588558BF6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3615091524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DD391442-22A8-D203-83A2-20B30A02AC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0F6B3EDC-DE56-520B-EEAE-BD18848C5338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1057118747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E338B253-4378-0863-FAD0-8BC5A8841A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AC551D45-0451-5A0C-6A3A-D4A31CC40D12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6</a:t>
            </a:r>
          </a:p>
        </p:txBody>
      </p:sp>
    </p:spTree>
    <p:extLst>
      <p:ext uri="{BB962C8B-B14F-4D97-AF65-F5344CB8AC3E}">
        <p14:creationId xmlns:p14="http://schemas.microsoft.com/office/powerpoint/2010/main" val="589912803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3225B871-EDA3-76E8-4AEF-5C1620DDF1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BD2FCDF5-DDA9-51E8-F527-E7DC121CD663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6</a:t>
            </a:r>
          </a:p>
        </p:txBody>
      </p:sp>
    </p:spTree>
    <p:extLst>
      <p:ext uri="{BB962C8B-B14F-4D97-AF65-F5344CB8AC3E}">
        <p14:creationId xmlns:p14="http://schemas.microsoft.com/office/powerpoint/2010/main" val="1468620783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229EE6A9-301C-EE1F-B6B8-8A216A377C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9D3B3945-E079-02FE-1D90-FDCCF7389578}"/>
              </a:ext>
            </a:extLst>
          </p:cNvPr>
          <p:cNvSpPr txBox="1"/>
          <p:nvPr/>
        </p:nvSpPr>
        <p:spPr>
          <a:xfrm>
            <a:off x="9538981" y="311705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6</a:t>
            </a:r>
          </a:p>
        </p:txBody>
      </p:sp>
    </p:spTree>
    <p:extLst>
      <p:ext uri="{BB962C8B-B14F-4D97-AF65-F5344CB8AC3E}">
        <p14:creationId xmlns:p14="http://schemas.microsoft.com/office/powerpoint/2010/main" val="16591787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0587EC0-B0B4-83FE-467D-E51D468D26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9798"/>
            <a:ext cx="12059478" cy="6847331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26403B94-B88E-2AB6-121B-9E1AA717FD1A}"/>
              </a:ext>
            </a:extLst>
          </p:cNvPr>
          <p:cNvSpPr txBox="1"/>
          <p:nvPr/>
        </p:nvSpPr>
        <p:spPr>
          <a:xfrm>
            <a:off x="9660835" y="291548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22286222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266639B7-5F7A-66E5-6469-1337C9D541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0337" y="557212"/>
            <a:ext cx="10583438" cy="6009240"/>
          </a:xfrm>
          <a:prstGeom prst="rect">
            <a:avLst/>
          </a:prstGeom>
        </p:spPr>
      </p:pic>
      <p:sp>
        <p:nvSpPr>
          <p:cNvPr id="2" name="CaixaDeTexto 1">
            <a:extLst>
              <a:ext uri="{FF2B5EF4-FFF2-40B4-BE49-F238E27FC236}">
                <a16:creationId xmlns:a16="http://schemas.microsoft.com/office/drawing/2014/main" id="{83448E1C-D07B-847B-6A54-6C461EC8F2BC}"/>
              </a:ext>
            </a:extLst>
          </p:cNvPr>
          <p:cNvSpPr txBox="1"/>
          <p:nvPr/>
        </p:nvSpPr>
        <p:spPr>
          <a:xfrm>
            <a:off x="9660835" y="291548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0213428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8EF993E5-B2D4-FC16-AC51-E05BE6556F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81037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D35AF0F5-8433-DE98-9680-928512DD22B5}"/>
              </a:ext>
            </a:extLst>
          </p:cNvPr>
          <p:cNvSpPr txBox="1"/>
          <p:nvPr/>
        </p:nvSpPr>
        <p:spPr>
          <a:xfrm>
            <a:off x="9660835" y="291548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8130742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547A97EB-CC53-484E-0E28-5730F88358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80C0D2D3-5BE3-6CA5-C509-1D6B75EBE03F}"/>
              </a:ext>
            </a:extLst>
          </p:cNvPr>
          <p:cNvSpPr txBox="1"/>
          <p:nvPr/>
        </p:nvSpPr>
        <p:spPr>
          <a:xfrm>
            <a:off x="9660835" y="291548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9024038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F1AC7661-0D01-93B0-6833-727C14FC32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9CD8FCC6-F881-0F95-169A-DF7A9B507180}"/>
              </a:ext>
            </a:extLst>
          </p:cNvPr>
          <p:cNvSpPr txBox="1"/>
          <p:nvPr/>
        </p:nvSpPr>
        <p:spPr>
          <a:xfrm>
            <a:off x="9660835" y="291548"/>
            <a:ext cx="181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33825393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12</TotalTime>
  <Words>79</Words>
  <Application>Microsoft Office PowerPoint</Application>
  <PresentationFormat>Widescreen</PresentationFormat>
  <Paragraphs>52</Paragraphs>
  <Slides>48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48</vt:i4>
      </vt:variant>
    </vt:vector>
  </HeadingPairs>
  <TitlesOfParts>
    <vt:vector size="52" baseType="lpstr">
      <vt:lpstr>Arial</vt:lpstr>
      <vt:lpstr>Calibri</vt:lpstr>
      <vt:lpstr>Calibri Light</vt:lpstr>
      <vt:lpstr>Tema do Office</vt:lpstr>
      <vt:lpstr>Supplementary material 1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   3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SI + (Amostras 2)</dc:title>
  <dc:creator>Bruna</dc:creator>
  <cp:lastModifiedBy>Geisa Caprini</cp:lastModifiedBy>
  <cp:revision>67</cp:revision>
  <dcterms:created xsi:type="dcterms:W3CDTF">2023-06-19T00:28:20Z</dcterms:created>
  <dcterms:modified xsi:type="dcterms:W3CDTF">2023-07-07T21:09:36Z</dcterms:modified>
</cp:coreProperties>
</file>